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7" r:id="rId2"/>
    <p:sldId id="284" r:id="rId3"/>
    <p:sldId id="285" r:id="rId4"/>
    <p:sldId id="287" r:id="rId5"/>
    <p:sldId id="273" r:id="rId6"/>
    <p:sldId id="275" r:id="rId7"/>
    <p:sldId id="277" r:id="rId8"/>
    <p:sldId id="279" r:id="rId9"/>
  </p:sldIdLst>
  <p:sldSz cx="6858000" cy="9906000" type="A4"/>
  <p:notesSz cx="6864350" cy="9998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lasquez, Zahady" initials="VZ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88" autoAdjust="0"/>
    <p:restoredTop sz="88444" autoAdjust="0"/>
  </p:normalViewPr>
  <p:slideViewPr>
    <p:cSldViewPr snapToGrid="0" showGuides="1">
      <p:cViewPr varScale="1">
        <p:scale>
          <a:sx n="72" d="100"/>
          <a:sy n="72" d="100"/>
        </p:scale>
        <p:origin x="3762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7788" y="0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9492D5-FD6D-4A33-84CC-6647E3F70FA4}" type="datetimeFigureOut">
              <a:rPr lang="de-DE" smtClean="0"/>
              <a:t>14.01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749300"/>
            <a:ext cx="25971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49800"/>
            <a:ext cx="5492750" cy="44989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96425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7788" y="9496425"/>
            <a:ext cx="2974975" cy="500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985956-12AB-4E7D-8C54-07AF3B2785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9889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143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175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56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32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31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244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499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947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371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030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344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6ADF8-7315-46F3-A407-DD81A5609A3F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D4DBA-9061-4694-889E-ACE77A94059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3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8" name="Gerader Verbinder 57"/>
          <p:cNvCxnSpPr/>
          <p:nvPr/>
        </p:nvCxnSpPr>
        <p:spPr>
          <a:xfrm>
            <a:off x="3339546" y="1819647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1 Grupo"/>
          <p:cNvGrpSpPr>
            <a:grpSpLocks noChangeAspect="1"/>
          </p:cNvGrpSpPr>
          <p:nvPr/>
        </p:nvGrpSpPr>
        <p:grpSpPr>
          <a:xfrm>
            <a:off x="190501" y="4190201"/>
            <a:ext cx="6438097" cy="3600000"/>
            <a:chOff x="1416340" y="6176009"/>
            <a:chExt cx="4377901" cy="2448001"/>
          </a:xfrm>
        </p:grpSpPr>
        <p:cxnSp>
          <p:nvCxnSpPr>
            <p:cNvPr id="30" name="Gerader Verbinder 44"/>
            <p:cNvCxnSpPr/>
            <p:nvPr/>
          </p:nvCxnSpPr>
          <p:spPr>
            <a:xfrm>
              <a:off x="1607733" y="7615709"/>
              <a:ext cx="38223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r Verbinder 45"/>
            <p:cNvCxnSpPr/>
            <p:nvPr/>
          </p:nvCxnSpPr>
          <p:spPr>
            <a:xfrm>
              <a:off x="1589400" y="7487379"/>
              <a:ext cx="0" cy="2566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r Verbinder 46"/>
            <p:cNvCxnSpPr/>
            <p:nvPr/>
          </p:nvCxnSpPr>
          <p:spPr>
            <a:xfrm>
              <a:off x="2845196" y="7450714"/>
              <a:ext cx="0" cy="2566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r Verbinder 47"/>
            <p:cNvCxnSpPr/>
            <p:nvPr/>
          </p:nvCxnSpPr>
          <p:spPr>
            <a:xfrm>
              <a:off x="4137657" y="7505712"/>
              <a:ext cx="0" cy="2566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r Verbinder 48"/>
            <p:cNvCxnSpPr/>
            <p:nvPr/>
          </p:nvCxnSpPr>
          <p:spPr>
            <a:xfrm>
              <a:off x="5418202" y="7505712"/>
              <a:ext cx="0" cy="2566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Geschweifte Klammer rechts 49"/>
            <p:cNvSpPr/>
            <p:nvPr/>
          </p:nvSpPr>
          <p:spPr>
            <a:xfrm rot="5400000">
              <a:off x="2022513" y="7365923"/>
              <a:ext cx="394154" cy="1251213"/>
            </a:xfrm>
            <a:prstGeom prst="rightBrace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de-DE" sz="4400"/>
            </a:p>
          </p:txBody>
        </p:sp>
        <p:sp>
          <p:nvSpPr>
            <p:cNvPr id="36" name="Geschweifte Klammer rechts 50"/>
            <p:cNvSpPr/>
            <p:nvPr/>
          </p:nvSpPr>
          <p:spPr>
            <a:xfrm rot="5400000">
              <a:off x="3292975" y="7376007"/>
              <a:ext cx="414319" cy="1251214"/>
            </a:xfrm>
            <a:prstGeom prst="rightBrace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de-DE" sz="4400"/>
            </a:p>
          </p:txBody>
        </p:sp>
        <p:sp>
          <p:nvSpPr>
            <p:cNvPr id="37" name="Geschweifte Klammer rechts 51"/>
            <p:cNvSpPr/>
            <p:nvPr/>
          </p:nvSpPr>
          <p:spPr>
            <a:xfrm rot="5400000">
              <a:off x="4597353" y="7365006"/>
              <a:ext cx="394154" cy="1269547"/>
            </a:xfrm>
            <a:prstGeom prst="rightBrace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de-DE" sz="4400"/>
            </a:p>
          </p:txBody>
        </p:sp>
        <p:sp>
          <p:nvSpPr>
            <p:cNvPr id="38" name="Geschweifte Klammer rechts 52"/>
            <p:cNvSpPr/>
            <p:nvPr/>
          </p:nvSpPr>
          <p:spPr>
            <a:xfrm rot="5400000">
              <a:off x="4138117" y="7821493"/>
              <a:ext cx="394154" cy="351073"/>
            </a:xfrm>
            <a:prstGeom prst="rightBrace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de-DE" sz="4400"/>
            </a:p>
          </p:txBody>
        </p:sp>
        <p:sp>
          <p:nvSpPr>
            <p:cNvPr id="39" name="Rechteck 53"/>
            <p:cNvSpPr/>
            <p:nvPr/>
          </p:nvSpPr>
          <p:spPr>
            <a:xfrm rot="16200000">
              <a:off x="1045895" y="6551614"/>
              <a:ext cx="1232879" cy="491989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>
                  <a:solidFill>
                    <a:schemeClr val="tx1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Cell </a:t>
              </a: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Seeding for individual inhibition assays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hteck 54"/>
            <p:cNvSpPr/>
            <p:nvPr/>
          </p:nvSpPr>
          <p:spPr>
            <a:xfrm rot="16200000">
              <a:off x="2219645" y="6695678"/>
              <a:ext cx="1247205" cy="207868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b="1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Inhibitors addition</a:t>
              </a:r>
              <a:endParaRPr lang="de-DE" sz="280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hteck 55"/>
            <p:cNvSpPr/>
            <p:nvPr/>
          </p:nvSpPr>
          <p:spPr>
            <a:xfrm rot="16200000">
              <a:off x="3516854" y="6696884"/>
              <a:ext cx="1239297" cy="207868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b="1" dirty="0">
                  <a:solidFill>
                    <a:schemeClr val="tx1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Wash / </a:t>
              </a: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Infection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Gerader Verbinder 56"/>
            <p:cNvCxnSpPr/>
            <p:nvPr/>
          </p:nvCxnSpPr>
          <p:spPr>
            <a:xfrm>
              <a:off x="4513479" y="7496546"/>
              <a:ext cx="0" cy="2566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hteck 57"/>
            <p:cNvSpPr/>
            <p:nvPr/>
          </p:nvSpPr>
          <p:spPr>
            <a:xfrm rot="16200000">
              <a:off x="3888709" y="6570632"/>
              <a:ext cx="1246627" cy="467703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Wash  / Inhibitors addition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hteck 58"/>
            <p:cNvSpPr/>
            <p:nvPr/>
          </p:nvSpPr>
          <p:spPr>
            <a:xfrm rot="16200000">
              <a:off x="4940743" y="6566966"/>
              <a:ext cx="1239294" cy="467703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End of infection /           treatment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hteck 59"/>
            <p:cNvSpPr/>
            <p:nvPr/>
          </p:nvSpPr>
          <p:spPr>
            <a:xfrm>
              <a:off x="1937723" y="8312353"/>
              <a:ext cx="549984" cy="29332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60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24h</a:t>
              </a:r>
              <a:endParaRPr lang="de-DE" sz="280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hteck 60"/>
            <p:cNvSpPr/>
            <p:nvPr/>
          </p:nvSpPr>
          <p:spPr>
            <a:xfrm>
              <a:off x="3221018" y="8330686"/>
              <a:ext cx="549984" cy="29332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600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24h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hteck 61"/>
            <p:cNvSpPr/>
            <p:nvPr/>
          </p:nvSpPr>
          <p:spPr>
            <a:xfrm>
              <a:off x="4693938" y="8284236"/>
              <a:ext cx="549984" cy="293324"/>
            </a:xfrm>
            <a:prstGeom prst="rect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600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24h</a:t>
              </a:r>
              <a:endParaRPr lang="de-DE" sz="28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Ellipse 62"/>
            <p:cNvSpPr/>
            <p:nvPr/>
          </p:nvSpPr>
          <p:spPr>
            <a:xfrm>
              <a:off x="4037005" y="8284236"/>
              <a:ext cx="596377" cy="303566"/>
            </a:xfrm>
            <a:prstGeom prst="ellipse">
              <a:avLst/>
            </a:prstGeom>
            <a:solidFill>
              <a:schemeClr val="accent1">
                <a:alpha val="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60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3h</a:t>
              </a:r>
              <a:endParaRPr lang="de-DE" sz="280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" name="Rechteck 53"/>
          <p:cNvSpPr/>
          <p:nvPr/>
        </p:nvSpPr>
        <p:spPr>
          <a:xfrm>
            <a:off x="1099071" y="1212019"/>
            <a:ext cx="1813057" cy="305689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plitting of host cells</a:t>
            </a:r>
            <a:endParaRPr lang="de-DE" sz="28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9" name="Gerader Verbinder 28"/>
          <p:cNvCxnSpPr/>
          <p:nvPr/>
        </p:nvCxnSpPr>
        <p:spPr>
          <a:xfrm flipH="1">
            <a:off x="729436" y="1821265"/>
            <a:ext cx="2612417" cy="21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>
            <a:off x="2003292" y="1531065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r Verbinder 49"/>
          <p:cNvCxnSpPr/>
          <p:nvPr/>
        </p:nvCxnSpPr>
        <p:spPr>
          <a:xfrm>
            <a:off x="729436" y="1819647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hteck 53"/>
          <p:cNvSpPr/>
          <p:nvPr/>
        </p:nvSpPr>
        <p:spPr>
          <a:xfrm>
            <a:off x="365039" y="1922863"/>
            <a:ext cx="720694" cy="103230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eding under</a:t>
            </a:r>
          </a:p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5% </a:t>
            </a:r>
            <a:r>
              <a:rPr lang="en-GB" sz="1600" dirty="0">
                <a:solidFill>
                  <a:schemeClr val="tx1"/>
                </a:solidFill>
              </a:rPr>
              <a:t>O</a:t>
            </a:r>
            <a:r>
              <a:rPr lang="en-GB" sz="1600" baseline="-25000" dirty="0">
                <a:solidFill>
                  <a:schemeClr val="tx1"/>
                </a:solidFill>
              </a:rPr>
              <a:t>2</a:t>
            </a:r>
            <a:r>
              <a:rPr lang="en-US" sz="11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de-DE" sz="24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2992122" y="1922863"/>
            <a:ext cx="720694" cy="103230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eding under</a:t>
            </a:r>
          </a:p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21% </a:t>
            </a:r>
            <a:r>
              <a:rPr lang="en-GB" sz="1600" dirty="0">
                <a:solidFill>
                  <a:schemeClr val="tx1"/>
                </a:solidFill>
              </a:rPr>
              <a:t>O</a:t>
            </a:r>
            <a:r>
              <a:rPr lang="en-GB" sz="1600" baseline="-25000" dirty="0">
                <a:solidFill>
                  <a:schemeClr val="tx1"/>
                </a:solidFill>
              </a:rPr>
              <a:t>2</a:t>
            </a:r>
            <a:r>
              <a:rPr lang="en-US" sz="11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de-DE" sz="24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55" name="Gerader Verbinder 54"/>
          <p:cNvCxnSpPr/>
          <p:nvPr/>
        </p:nvCxnSpPr>
        <p:spPr>
          <a:xfrm>
            <a:off x="722263" y="2956884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r Verbinder 55"/>
          <p:cNvCxnSpPr/>
          <p:nvPr/>
        </p:nvCxnSpPr>
        <p:spPr>
          <a:xfrm>
            <a:off x="3339546" y="2956884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r Verbinder 56"/>
          <p:cNvCxnSpPr/>
          <p:nvPr/>
        </p:nvCxnSpPr>
        <p:spPr>
          <a:xfrm flipH="1">
            <a:off x="722263" y="3232736"/>
            <a:ext cx="2617284" cy="7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echteck 53"/>
          <p:cNvSpPr/>
          <p:nvPr/>
        </p:nvSpPr>
        <p:spPr>
          <a:xfrm>
            <a:off x="914013" y="2991071"/>
            <a:ext cx="2178557" cy="61636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ost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ell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evelopment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under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elected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tmospheres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2 </a:t>
            </a:r>
            <a:r>
              <a:rPr lang="de-DE" sz="1200" b="1" dirty="0" err="1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passages</a:t>
            </a:r>
            <a:r>
              <a:rPr lang="de-DE" sz="1200" b="1" dirty="0">
                <a:solidFill>
                  <a:schemeClr val="tx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de-DE" sz="2400" dirty="0">
              <a:solidFill>
                <a:schemeClr val="tx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0" name="Gerader Verbinder 59"/>
          <p:cNvCxnSpPr/>
          <p:nvPr/>
        </p:nvCxnSpPr>
        <p:spPr>
          <a:xfrm>
            <a:off x="1984386" y="3619692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r Verbinder 60"/>
          <p:cNvCxnSpPr/>
          <p:nvPr/>
        </p:nvCxnSpPr>
        <p:spPr>
          <a:xfrm flipH="1">
            <a:off x="490405" y="3903998"/>
            <a:ext cx="1493981" cy="21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r Verbinder 62"/>
          <p:cNvCxnSpPr/>
          <p:nvPr/>
        </p:nvCxnSpPr>
        <p:spPr>
          <a:xfrm>
            <a:off x="489251" y="3902894"/>
            <a:ext cx="2307" cy="2832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130"/>
          <p:cNvSpPr txBox="1">
            <a:spLocks noChangeArrowheads="1"/>
          </p:cNvSpPr>
          <p:nvPr/>
        </p:nvSpPr>
        <p:spPr bwMode="auto">
          <a:xfrm>
            <a:off x="0" y="8504402"/>
            <a:ext cx="6858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Treatment/infection schema </a:t>
            </a:r>
            <a:endParaRPr 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7628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30"/>
          <p:cNvSpPr txBox="1">
            <a:spLocks noChangeArrowheads="1"/>
          </p:cNvSpPr>
          <p:nvPr/>
        </p:nvSpPr>
        <p:spPr bwMode="auto">
          <a:xfrm>
            <a:off x="0" y="7971346"/>
            <a:ext cx="6858000" cy="4985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Galloflavin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lonidamine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syrosingopine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and compound 968 on HCT-8 cells viability by means of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XTT under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 descr="C:\Users\Usuario\Google Drive\Doktorarbeit\Juan Doktorarbeit\Cryptosporidium\Reportes\LDH 060619 JV\Results viroskant\XTT\LONIDAMINE HCT-8 viability (XTT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2169" y="1759997"/>
            <a:ext cx="3349625" cy="2557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Usuario\Google Drive\Doktorarbeit\Juan Doktorarbeit\Cryptosporidium\Reportes\LDH 060619 JV\Results viroskant\XTT\GALLOFLAVIN HCT-8 viability (XTT)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568" y="1705228"/>
            <a:ext cx="2882900" cy="2667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C:\Users\Usuario\Google Drive\Doktorarbeit\Juan Doktorarbeit\Cryptosporidium\Reportes\Reportes\LDH 060819 JV\Viroskan archives of XTT assay\Syrosingopine XTT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853427"/>
            <a:ext cx="3602037" cy="2667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5" descr="C:\Users\Usuario\Google Drive\Doktorarbeit\Juan Doktorarbeit\Cryptosporidium\Reportes\Reportes\LDH 060819 JV\Viroskan archives of XTT assay\C968 XTT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5963" y="4871684"/>
            <a:ext cx="3602037" cy="2630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26772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30"/>
          <p:cNvSpPr txBox="1">
            <a:spLocks noChangeArrowheads="1"/>
          </p:cNvSpPr>
          <p:nvPr/>
        </p:nvSpPr>
        <p:spPr bwMode="auto">
          <a:xfrm>
            <a:off x="0" y="9009318"/>
            <a:ext cx="6858000" cy="4985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Lonidamine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syrosingopine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and compound 968 on HCT-8 cells viability by means of LDH-measurement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under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21% 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C:\Users\Usuario\Google Drive\Doktorarbeit\Juan Doktorarbeit\Cryptosporidium\Reportes\LDH 060619 JV\Results biochemistry\Cell viability\LONIDAMINE HCT-8 viability (LDH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128576"/>
            <a:ext cx="2879725" cy="2557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Usuario\Google Drive\Doktorarbeit\Juan Doktorarbeit\Cryptosporidium\Reportes\Reportes\LDH 060819 JV\Resultados Biochemistry\Cell viability\Syrosingopine LDH_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119" y="2055552"/>
            <a:ext cx="3602037" cy="2630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C:\Users\Usuario\Google Drive\Doktorarbeit\Juan Doktorarbeit\Cryptosporidium\Reportes\Reportes\LDH 060819 JV\Resultados Biochemistry\Cell viability\c968 LDH_2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100" y="5198803"/>
            <a:ext cx="3602037" cy="2630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88487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elle 10">
            <a:extLst>
              <a:ext uri="{FF2B5EF4-FFF2-40B4-BE49-F238E27FC236}">
                <a16:creationId xmlns:a16="http://schemas.microsoft.com/office/drawing/2014/main" xmlns="" id="{5AA9EF53-A44F-4196-9FFE-B81D232494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3062963"/>
              </p:ext>
            </p:extLst>
          </p:nvPr>
        </p:nvGraphicFramePr>
        <p:xfrm>
          <a:off x="358345" y="6332633"/>
          <a:ext cx="5840573" cy="2199640"/>
        </p:xfrm>
        <a:graphic>
          <a:graphicData uri="http://schemas.openxmlformats.org/drawingml/2006/table">
            <a:tbl>
              <a:tblPr firstRow="1" firstCol="1" bandRow="1"/>
              <a:tblGrid>
                <a:gridCol w="1458816">
                  <a:extLst>
                    <a:ext uri="{9D8B030D-6E8A-4147-A177-3AD203B41FA5}">
                      <a16:colId xmlns:a16="http://schemas.microsoft.com/office/drawing/2014/main" xmlns="" val="1771194899"/>
                    </a:ext>
                  </a:extLst>
                </a:gridCol>
                <a:gridCol w="2347092">
                  <a:extLst>
                    <a:ext uri="{9D8B030D-6E8A-4147-A177-3AD203B41FA5}">
                      <a16:colId xmlns:a16="http://schemas.microsoft.com/office/drawing/2014/main" xmlns="" val="971244147"/>
                    </a:ext>
                  </a:extLst>
                </a:gridCol>
                <a:gridCol w="2034665">
                  <a:extLst>
                    <a:ext uri="{9D8B030D-6E8A-4147-A177-3AD203B41FA5}">
                      <a16:colId xmlns:a16="http://schemas.microsoft.com/office/drawing/2014/main" xmlns="" val="595323140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tamin/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cose</a:t>
                      </a:r>
                      <a:endParaRPr lang="de-DE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% O</a:t>
                      </a:r>
                      <a:r>
                        <a:rPr lang="de-DE" sz="1200" b="1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de-DE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65874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1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xygen</a:t>
                      </a:r>
                      <a:r>
                        <a:rPr lang="de-DE" sz="1100" b="1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b="1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dition</a:t>
                      </a:r>
                      <a:endParaRPr lang="de-DE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de-DE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05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nfected</a:t>
                      </a:r>
                      <a:r>
                        <a:rPr kumimoji="0" lang="de-DE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CT-8 </a:t>
                      </a:r>
                      <a:r>
                        <a:rPr kumimoji="0" lang="de-DE" sz="105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kumimoji="0" lang="de-DE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endParaRPr lang="de-DE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endParaRPr lang="de-DE" sz="105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5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.</a:t>
                      </a:r>
                      <a:r>
                        <a:rPr lang="de-DE" sz="1050" i="1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50" i="1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rvum</a:t>
                      </a:r>
                      <a:r>
                        <a:rPr lang="de-DE" sz="105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infected</a:t>
                      </a:r>
                      <a:r>
                        <a:rPr lang="de-DE" sz="105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HCT-8 </a:t>
                      </a:r>
                      <a:r>
                        <a:rPr lang="de-DE" sz="105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de-DE" sz="105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1000"/>
                        </a:spcAft>
                      </a:pPr>
                      <a:endParaRPr lang="de-DE" sz="105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765586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lope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,49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,39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750696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ercept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 0,01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 5,50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316814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,55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de-DE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,92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4915092"/>
                  </a:ext>
                </a:extLst>
              </a:tr>
            </a:tbl>
          </a:graphicData>
        </a:graphic>
      </p:graphicFrame>
      <p:sp>
        <p:nvSpPr>
          <p:cNvPr id="13" name="Textfeld 130">
            <a:extLst>
              <a:ext uri="{FF2B5EF4-FFF2-40B4-BE49-F238E27FC236}">
                <a16:creationId xmlns:a16="http://schemas.microsoft.com/office/drawing/2014/main" xmlns="" id="{3651FC99-ECAF-49DB-A660-C57BED1D58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8824598"/>
            <a:ext cx="6858000" cy="4985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Correlation between glutamine and glucose consumption in </a:t>
            </a:r>
            <a:r>
              <a:rPr lang="en-US" altLang="de-DE" sz="1200" b="0" i="1" dirty="0">
                <a:latin typeface="Arial" panose="020B0604020202020204" pitchFamily="34" charset="0"/>
                <a:cs typeface="Arial" panose="020B0604020202020204" pitchFamily="34" charset="0"/>
              </a:rPr>
              <a:t>C. parvum-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infected HCT-8 cells  under 5 %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8522"/>
            <a:ext cx="6858000" cy="5591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82534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6" name="Picture 6" descr="C:\Users\Juan\Google Drive\Doktorarbeit\Juan Doktorarbeit\Cryptosporidium\Publicaciones\1\Intento 2_AT\correcciones\Mazurek_1\Corregido\Energymaps\Glycolysis\Non-glycolytic acidification_Gallo_Mazurek_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2752" y="4024000"/>
            <a:ext cx="3652449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Juan\Google Drive\Doktorarbeit\Juan Doktorarbeit\Cryptosporidium\Publicaciones\1\Intento 2_AT\correcciones\Mazurek_1\Corregido\Energymaps\Glycolysis\Glycolytic reserve_Gallo_Mazurek_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2468" y="1019178"/>
            <a:ext cx="3434610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2" name="Picture 2" descr="C:\Users\Juan\Google Drive\Doktorarbeit\Juan Doktorarbeit\Cryptosporidium\Publicaciones\1\Intento 2_AT\correcciones\Mazurek_1\Corregido\Energymaps\Glycolysis\Glycolytic capacity_Gallo_Mazurek_1.tif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911" y="959803"/>
            <a:ext cx="3240000" cy="2897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130"/>
          <p:cNvSpPr txBox="1">
            <a:spLocks noChangeArrowheads="1"/>
          </p:cNvSpPr>
          <p:nvPr/>
        </p:nvSpPr>
        <p:spPr bwMode="auto">
          <a:xfrm>
            <a:off x="0" y="7404999"/>
            <a:ext cx="6858000" cy="904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Galloflavin´s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effect on glycolytic capacity (A), glycolytic reserve (B) and non-glycolytic acidification (C) of </a:t>
            </a:r>
            <a:r>
              <a:rPr lang="en-US" altLang="de-DE" sz="1200" b="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de-DE" sz="12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parvum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-infected HCT-8 cells under 21%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de-DE" sz="1200" b="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de-DE" sz="800" b="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0000"/>
              </a:lnSpc>
            </a:pP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0000"/>
              </a:lnSpc>
            </a:pP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31293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31293" y="6727891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429000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439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8" name="Picture 4" descr="C:\Users\Juan\Google Drive\Doktorarbeit\Juan Doktorarbeit\Cryptosporidium\Publicaciones\1\Intento 2_AT\correcciones\Mazurek_1\Corregido\Energymaps\Glycolysis\Non-Glycolytic acidification_Loni_Mazurek_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469" y="3988375"/>
            <a:ext cx="3334481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Juan\Google Drive\Doktorarbeit\Juan Doktorarbeit\Cryptosporidium\Publicaciones\1\Intento 2_AT\correcciones\Mazurek_1\Corregido\Energymaps\Glycolysis\Glycolytic reserve_Loni_Mazurek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1779" y="1007303"/>
            <a:ext cx="3439198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6" name="Picture 2" descr="C:\Users\Juan\Google Drive\Doktorarbeit\Juan Doktorarbeit\Cryptosporidium\Publicaciones\1\Intento 2_AT\correcciones\Mazurek_1\Corregido\Energymaps\Glycolysis\Glycolytic capacity_Loni_Mazurek_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87" y="983553"/>
            <a:ext cx="3334481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130"/>
          <p:cNvSpPr txBox="1">
            <a:spLocks noChangeArrowheads="1"/>
          </p:cNvSpPr>
          <p:nvPr/>
        </p:nvSpPr>
        <p:spPr bwMode="auto">
          <a:xfrm>
            <a:off x="0" y="7798356"/>
            <a:ext cx="6858000" cy="701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Lonidamine´s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effect on glycolytic capacity (A), glycolytic reserve (B) and non-glycolytic acidification (C) of </a:t>
            </a:r>
            <a:r>
              <a:rPr lang="en-US" altLang="de-DE" sz="1200" b="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de-DE" sz="12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parvum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-infected HCT-8 cells under 21%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</a:p>
          <a:p>
            <a:pPr algn="just">
              <a:lnSpc>
                <a:spcPct val="110000"/>
              </a:lnSpc>
            </a:pPr>
            <a:endParaRPr lang="en-US" altLang="de-DE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31293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31293" y="6727891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429000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9888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2" name="Picture 4" descr="C:\Users\Juan\Google Drive\Doktorarbeit\Juan Doktorarbeit\Cryptosporidium\Publicaciones\1\Intento 2_AT\correcciones\Mazurek_1\Corregido\Energymaps\Glycolysis\Non-glycolytic acidification_syro_Mazurek_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469" y="3988375"/>
            <a:ext cx="3350805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C:\Users\Juan\Google Drive\Doktorarbeit\Juan Doktorarbeit\Cryptosporidium\Publicaciones\1\Intento 2_AT\correcciones\Mazurek_1\Corregido\Energymaps\Glycolysis\Glycolytic reserve_syro_Mazurek_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4344" y="936053"/>
            <a:ext cx="3170897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0" name="Picture 2" descr="C:\Users\Juan\Google Drive\Doktorarbeit\Juan Doktorarbeit\Cryptosporidium\Publicaciones\1\Intento 2_AT\correcciones\Mazurek_1\Corregido\Energymaps\Glycolysis\Glycolytic capacity_syro_Mazurek_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243" y="972666"/>
            <a:ext cx="3346531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130"/>
          <p:cNvSpPr txBox="1">
            <a:spLocks noChangeArrowheads="1"/>
          </p:cNvSpPr>
          <p:nvPr/>
        </p:nvSpPr>
        <p:spPr bwMode="auto">
          <a:xfrm>
            <a:off x="0" y="7897210"/>
            <a:ext cx="6858000" cy="4985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altLang="de-DE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Syrosingopine´s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effect on glycolytic capacity (A), glycolytic reserve (B) and non-glycolytic acidification (C) of </a:t>
            </a:r>
            <a:r>
              <a:rPr lang="en-US" altLang="de-DE" sz="1200" b="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de-DE" sz="12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parvum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-infected HCT-8 cells under 21% 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31293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31293" y="6727891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429000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5487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6" name="Picture 4" descr="C:\Users\Juan\Google Drive\Doktorarbeit\Juan Doktorarbeit\Cryptosporidium\Publicaciones\1\Intento 2_AT\correcciones\Mazurek_1\Corregido\Energymaps\Glycolysis\Non-glycolytic acidification_c968_Mazurek_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862" y="4000250"/>
            <a:ext cx="3334481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C:\Users\Juan\Google Drive\Doktorarbeit\Juan Doktorarbeit\Cryptosporidium\Publicaciones\1\Intento 2_AT\correcciones\Mazurek_1\Corregido\Energymaps\Glycolysis\glycolytic reserve_c968_Mazurek_1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2582" y="936053"/>
            <a:ext cx="3240000" cy="29566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4" name="Picture 2" descr="C:\Users\Juan\Google Drive\Doktorarbeit\Juan Doktorarbeit\Cryptosporidium\Publicaciones\1\Intento 2_AT\correcciones\Mazurek_1\Corregido\Energymaps\Glycolysis\glycolytic capacity_c968_Mazurek_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243" y="983553"/>
            <a:ext cx="3334481" cy="28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feld 130"/>
          <p:cNvSpPr txBox="1">
            <a:spLocks noChangeArrowheads="1"/>
          </p:cNvSpPr>
          <p:nvPr/>
        </p:nvSpPr>
        <p:spPr bwMode="auto">
          <a:xfrm>
            <a:off x="0" y="7800650"/>
            <a:ext cx="6858000" cy="4985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" panose="02020603050405020304" pitchFamily="18" charset="0"/>
              </a:defRPr>
            </a:lvl9pPr>
          </a:lstStyle>
          <a:p>
            <a:pPr algn="just">
              <a:lnSpc>
                <a:spcPct val="110000"/>
              </a:lnSpc>
            </a:pP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r>
              <a:rPr lang="en-US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Analysis of Compound 968 effect on glycolytic capacity (A), glycolytic reserve (B) and non-glycolytic acidification (C) of </a:t>
            </a:r>
            <a:r>
              <a:rPr lang="en-US" altLang="de-DE" sz="1200" b="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de-DE" sz="1200" b="0" i="1" dirty="0" err="1">
                <a:latin typeface="Arial" panose="020B0604020202020204" pitchFamily="34" charset="0"/>
                <a:cs typeface="Arial" panose="020B0604020202020204" pitchFamily="34" charset="0"/>
              </a:rPr>
              <a:t>parvum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-infected HCT-8 cells under 21% O</a:t>
            </a:r>
            <a:r>
              <a:rPr lang="en-US" altLang="de-DE" sz="1200" b="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de-DE" sz="1200" b="0" dirty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31293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31293" y="6727891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429000" y="3330520"/>
            <a:ext cx="638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3947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5</Words>
  <Application>Microsoft Office PowerPoint</Application>
  <PresentationFormat>A4-Papier (210x297 mm)</PresentationFormat>
  <Paragraphs>53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lasquez, Zahady</dc:creator>
  <cp:lastModifiedBy>Juan Velez</cp:lastModifiedBy>
  <cp:revision>351</cp:revision>
  <cp:lastPrinted>2020-06-02T12:38:49Z</cp:lastPrinted>
  <dcterms:created xsi:type="dcterms:W3CDTF">2019-04-16T11:40:20Z</dcterms:created>
  <dcterms:modified xsi:type="dcterms:W3CDTF">2021-01-14T18:43:26Z</dcterms:modified>
</cp:coreProperties>
</file>